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72" autoAdjust="0"/>
  </p:normalViewPr>
  <p:slideViewPr>
    <p:cSldViewPr>
      <p:cViewPr>
        <p:scale>
          <a:sx n="60" d="100"/>
          <a:sy n="60" d="100"/>
        </p:scale>
        <p:origin x="-1704" y="-2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3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012A69-0654-4BD3-A0AF-747B65ECD7CD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9890D5-6B41-497F-9E45-E3147D98367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77120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</a:t>
            </a:r>
            <a:r>
              <a:rPr lang="en-SG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SG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: </a:t>
            </a:r>
            <a:r>
              <a:rPr lang="en-SG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pression of BirA* and BirA_ATG8 constructs.</a:t>
            </a:r>
            <a:endParaRPr lang="en-SG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SG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 Graphical representation of control BirA*and experimental plasmids BirA*-ATG8. Full gel image for figure 2A carried out using anti-</a:t>
            </a:r>
            <a:r>
              <a:rPr lang="en-SG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Cherry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SG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seri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for both (b) &amp; (c) and anti-ATG8 antiserum (* indicates a weak band)</a:t>
            </a:r>
          </a:p>
          <a:p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 to ascertain fusion protein expression. Expected sizes of the fusion proteins BirA-ATG8-and </a:t>
            </a:r>
            <a:r>
              <a:rPr lang="en-SG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rA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e ~81.8 </a:t>
            </a:r>
            <a:r>
              <a:rPr lang="en-SG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Da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~66.8 </a:t>
            </a:r>
            <a:r>
              <a:rPr lang="en-SG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Da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size, respectively. (e) Detection of RFP signals from </a:t>
            </a:r>
            <a:r>
              <a:rPr lang="en-SG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groinfiltrated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SG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.benthamiana</a:t>
            </a:r>
            <a:r>
              <a:rPr lang="en-SG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ves to confirm expression of RFP-fused </a:t>
            </a:r>
            <a:r>
              <a:rPr lang="en-SG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rA</a:t>
            </a:r>
            <a:r>
              <a:rPr lang="en-SG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</a:t>
            </a:r>
            <a:r>
              <a:rPr lang="en-SG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SG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rA</a:t>
            </a:r>
            <a:r>
              <a:rPr lang="en-SG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-ATG8 .</a:t>
            </a:r>
            <a:endParaRPr lang="en-SG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E8354C-DFA6-4502-8C32-C250C8427A9A}" type="slidenum">
              <a:rPr lang="en-SG" smtClean="0"/>
              <a:t>1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3849529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46835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87111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9019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97628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15955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95113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66639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20219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11030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776469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93440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7465CF-648C-4E31-8090-65C0DD5D46E4}" type="datetimeFigureOut">
              <a:rPr lang="en-SG" smtClean="0"/>
              <a:t>3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31F0B-37F3-4322-9352-A84F867EBE26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412278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3" Type="http://schemas.openxmlformats.org/officeDocument/2006/relationships/image" Target="../media/image1.jpeg"/><Relationship Id="rId7" Type="http://schemas.openxmlformats.org/officeDocument/2006/relationships/image" Target="../media/image3.png"/><Relationship Id="rId12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2.jpeg"/><Relationship Id="rId15" Type="http://schemas.openxmlformats.org/officeDocument/2006/relationships/image" Target="../media/image10.png"/><Relationship Id="rId10" Type="http://schemas.openxmlformats.org/officeDocument/2006/relationships/image" Target="../media/image5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94631" y="2009560"/>
            <a:ext cx="2311837" cy="2919404"/>
            <a:chOff x="5484680" y="425136"/>
            <a:chExt cx="2311837" cy="2919404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58" r="27756" b="8676"/>
            <a:stretch/>
          </p:blipFill>
          <p:spPr>
            <a:xfrm>
              <a:off x="6012160" y="2033653"/>
              <a:ext cx="1784357" cy="1310887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5498304" y="2622882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/>
                <a:t>25</a:t>
              </a:r>
              <a:endParaRPr lang="en-SG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84680" y="2430143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/>
                <a:t>4</a:t>
              </a:r>
              <a:r>
                <a:rPr lang="en-SG" b="1" dirty="0" smtClean="0"/>
                <a:t>5</a:t>
              </a:r>
              <a:endParaRPr lang="en-SG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498304" y="2180180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/>
                <a:t>7</a:t>
              </a:r>
              <a:r>
                <a:rPr lang="en-SG" b="1" dirty="0" smtClean="0"/>
                <a:t>5</a:t>
              </a:r>
              <a:endParaRPr lang="en-SG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270544" y="425136"/>
              <a:ext cx="461665" cy="160851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SG" b="1" dirty="0" smtClean="0"/>
                <a:t>RFP-</a:t>
              </a:r>
              <a:r>
                <a:rPr lang="en-SG" b="1" dirty="0" err="1" smtClean="0"/>
                <a:t>BirA</a:t>
              </a:r>
              <a:r>
                <a:rPr lang="en-SG" b="1" dirty="0" smtClean="0"/>
                <a:t>*-ATG8</a:t>
              </a:r>
              <a:endParaRPr lang="en-SG" b="1" dirty="0"/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5104096" y="2373178"/>
            <a:ext cx="2722092" cy="2072451"/>
            <a:chOff x="1158987" y="3546588"/>
            <a:chExt cx="2722092" cy="2072451"/>
          </a:xfrm>
        </p:grpSpPr>
        <p:grpSp>
          <p:nvGrpSpPr>
            <p:cNvPr id="3" name="Group 2"/>
            <p:cNvGrpSpPr/>
            <p:nvPr/>
          </p:nvGrpSpPr>
          <p:grpSpPr>
            <a:xfrm>
              <a:off x="1158987" y="4723572"/>
              <a:ext cx="2722092" cy="895467"/>
              <a:chOff x="5496833" y="3535046"/>
              <a:chExt cx="2722092" cy="895467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aturation sat="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3867" b="35930"/>
              <a:stretch/>
            </p:blipFill>
            <p:spPr>
              <a:xfrm>
                <a:off x="6012160" y="3536975"/>
                <a:ext cx="2206765" cy="839882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5496833" y="4061181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SG" b="1" dirty="0" smtClean="0"/>
                  <a:t>25</a:t>
                </a:r>
                <a:endParaRPr lang="en-SG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496833" y="353504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SG" b="1" dirty="0"/>
                  <a:t>7</a:t>
                </a:r>
                <a:r>
                  <a:rPr lang="en-SG" b="1" dirty="0" smtClean="0"/>
                  <a:t>5</a:t>
                </a:r>
                <a:endParaRPr lang="en-SG" b="1" dirty="0"/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2181799" y="4110588"/>
              <a:ext cx="461665" cy="61491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SG" b="1" dirty="0" smtClean="0"/>
                <a:t>BirA*</a:t>
              </a:r>
              <a:endParaRPr lang="en-SG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151199" y="3546588"/>
              <a:ext cx="461665" cy="117891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SG" b="1" dirty="0" smtClean="0"/>
                <a:t>BirA*-ATG8</a:t>
              </a:r>
              <a:endParaRPr lang="en-SG" b="1" dirty="0"/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1549372" y="2545168"/>
            <a:ext cx="461665" cy="104451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SG" b="1" dirty="0" smtClean="0"/>
              <a:t>RFP-</a:t>
            </a:r>
            <a:r>
              <a:rPr lang="en-SG" b="1" dirty="0" err="1" smtClean="0"/>
              <a:t>BirA</a:t>
            </a:r>
            <a:r>
              <a:rPr lang="en-SG" b="1" dirty="0" smtClean="0"/>
              <a:t>*</a:t>
            </a:r>
            <a:endParaRPr lang="en-SG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2051721" y="160154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SG" dirty="0"/>
          </a:p>
        </p:txBody>
      </p:sp>
      <p:grpSp>
        <p:nvGrpSpPr>
          <p:cNvPr id="51" name="Group 50"/>
          <p:cNvGrpSpPr/>
          <p:nvPr/>
        </p:nvGrpSpPr>
        <p:grpSpPr>
          <a:xfrm>
            <a:off x="597473" y="5007946"/>
            <a:ext cx="2156134" cy="2145750"/>
            <a:chOff x="1036192" y="3551234"/>
            <a:chExt cx="2156134" cy="2145750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82" t="8643" r="42791" b="11382"/>
            <a:stretch/>
          </p:blipFill>
          <p:spPr bwMode="auto">
            <a:xfrm>
              <a:off x="1562153" y="3987166"/>
              <a:ext cx="1518347" cy="13404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43" name="Straight Connector 42"/>
            <p:cNvCxnSpPr/>
            <p:nvPr/>
          </p:nvCxnSpPr>
          <p:spPr>
            <a:xfrm>
              <a:off x="1377738" y="4331692"/>
              <a:ext cx="1524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1391185" y="4725144"/>
              <a:ext cx="1524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1036192" y="4147026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/>
                <a:t>72</a:t>
              </a:r>
              <a:endParaRPr lang="en-SG" b="1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036192" y="4540478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/>
                <a:t>42</a:t>
              </a:r>
              <a:endParaRPr lang="en-SG" b="1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002577" y="3551234"/>
              <a:ext cx="11897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/>
                <a:t>RFP -BirA*</a:t>
              </a:r>
              <a:endParaRPr lang="en-SG" b="1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961669" y="5327652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SG" b="1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508105" y="487371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SG" dirty="0"/>
          </a:p>
        </p:txBody>
      </p:sp>
      <p:sp>
        <p:nvSpPr>
          <p:cNvPr id="23" name="TextBox 22"/>
          <p:cNvSpPr txBox="1"/>
          <p:nvPr/>
        </p:nvSpPr>
        <p:spPr>
          <a:xfrm>
            <a:off x="101934" y="290685"/>
            <a:ext cx="68961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3200" b="1" dirty="0" smtClean="0"/>
              <a:t>(A)</a:t>
            </a:r>
            <a:endParaRPr lang="en-SG" sz="32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105842" y="2713481"/>
            <a:ext cx="67197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3200" b="1" dirty="0" smtClean="0"/>
              <a:t>(B)</a:t>
            </a:r>
            <a:endParaRPr lang="en-SG" sz="32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65501" y="4907710"/>
            <a:ext cx="65915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3200" b="1" dirty="0" smtClean="0"/>
              <a:t>(C)</a:t>
            </a:r>
            <a:endParaRPr lang="en-SG" sz="3200" b="1" dirty="0"/>
          </a:p>
        </p:txBody>
      </p:sp>
      <p:grpSp>
        <p:nvGrpSpPr>
          <p:cNvPr id="46" name="Group 45"/>
          <p:cNvGrpSpPr/>
          <p:nvPr/>
        </p:nvGrpSpPr>
        <p:grpSpPr>
          <a:xfrm>
            <a:off x="1370536" y="692542"/>
            <a:ext cx="7402937" cy="909001"/>
            <a:chOff x="1316230" y="2440053"/>
            <a:chExt cx="7402937" cy="909001"/>
          </a:xfrm>
        </p:grpSpPr>
        <p:grpSp>
          <p:nvGrpSpPr>
            <p:cNvPr id="47" name="Group 46"/>
            <p:cNvGrpSpPr/>
            <p:nvPr/>
          </p:nvGrpSpPr>
          <p:grpSpPr>
            <a:xfrm>
              <a:off x="3312221" y="2473963"/>
              <a:ext cx="4748707" cy="834106"/>
              <a:chOff x="1452405" y="2636912"/>
              <a:chExt cx="5495859" cy="1045074"/>
            </a:xfrm>
          </p:grpSpPr>
          <p:sp>
            <p:nvSpPr>
              <p:cNvPr id="58" name="Rectangle 57"/>
              <p:cNvSpPr/>
              <p:nvPr/>
            </p:nvSpPr>
            <p:spPr>
              <a:xfrm>
                <a:off x="1452405" y="2636912"/>
                <a:ext cx="1463411" cy="3600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G" b="1" dirty="0" err="1" smtClean="0">
                    <a:solidFill>
                      <a:schemeClr val="tx1"/>
                    </a:solidFill>
                    <a:latin typeface="+mj-lt"/>
                  </a:rPr>
                  <a:t>mCherry</a:t>
                </a:r>
                <a:endParaRPr lang="en-SG" b="1" dirty="0">
                  <a:solidFill>
                    <a:schemeClr val="tx1"/>
                  </a:solidFill>
                  <a:latin typeface="+mj-lt"/>
                </a:endParaRP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2915816" y="2636912"/>
                <a:ext cx="648072" cy="3600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G" b="1" dirty="0">
                    <a:solidFill>
                      <a:schemeClr val="tx1"/>
                    </a:solidFill>
                    <a:latin typeface="+mj-lt"/>
                  </a:rPr>
                  <a:t>HA</a:t>
                </a: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3563888" y="2636912"/>
                <a:ext cx="2088232" cy="3600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G" b="1" dirty="0">
                    <a:solidFill>
                      <a:schemeClr val="tx1"/>
                    </a:solidFill>
                    <a:latin typeface="+mj-lt"/>
                  </a:rPr>
                  <a:t>BirA</a:t>
                </a: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5652120" y="2636912"/>
                <a:ext cx="1296144" cy="3600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G" b="1" dirty="0">
                    <a:solidFill>
                      <a:schemeClr val="tx1"/>
                    </a:solidFill>
                    <a:latin typeface="+mj-lt"/>
                  </a:rPr>
                  <a:t>ATG8</a:t>
                </a: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1481014" y="3321946"/>
                <a:ext cx="1463411" cy="3600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G" b="1" dirty="0" err="1" smtClean="0">
                    <a:solidFill>
                      <a:schemeClr val="tx1"/>
                    </a:solidFill>
                    <a:latin typeface="+mj-lt"/>
                  </a:rPr>
                  <a:t>mCherry</a:t>
                </a:r>
                <a:endParaRPr lang="en-SG" b="1" dirty="0">
                  <a:solidFill>
                    <a:schemeClr val="tx1"/>
                  </a:solidFill>
                  <a:latin typeface="+mj-lt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2944425" y="3321946"/>
                <a:ext cx="648072" cy="3600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G" b="1" dirty="0">
                    <a:solidFill>
                      <a:schemeClr val="tx1"/>
                    </a:solidFill>
                    <a:latin typeface="+mj-lt"/>
                  </a:rPr>
                  <a:t>HA</a:t>
                </a: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3563888" y="3321946"/>
                <a:ext cx="2117810" cy="3600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SG" b="1" dirty="0">
                    <a:solidFill>
                      <a:schemeClr val="tx1"/>
                    </a:solidFill>
                    <a:latin typeface="+mj-lt"/>
                  </a:rPr>
                  <a:t>BirA</a:t>
                </a:r>
              </a:p>
            </p:txBody>
          </p:sp>
        </p:grpSp>
        <p:sp>
          <p:nvSpPr>
            <p:cNvPr id="49" name="TextBox 48"/>
            <p:cNvSpPr txBox="1"/>
            <p:nvPr/>
          </p:nvSpPr>
          <p:spPr>
            <a:xfrm>
              <a:off x="1316230" y="2440053"/>
              <a:ext cx="12712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>
                  <a:latin typeface="+mj-lt"/>
                </a:rPr>
                <a:t>BirA*-ATG8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316230" y="2979722"/>
              <a:ext cx="7072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>
                  <a:latin typeface="+mj-lt"/>
                </a:rPr>
                <a:t>BirA*</a:t>
              </a:r>
            </a:p>
          </p:txBody>
        </p:sp>
        <p:pic>
          <p:nvPicPr>
            <p:cNvPr id="54" name="Picture 2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20" t="1" b="-1"/>
            <a:stretch/>
          </p:blipFill>
          <p:spPr bwMode="auto">
            <a:xfrm>
              <a:off x="8060928" y="2595107"/>
              <a:ext cx="658239" cy="881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5" name="Picture 2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20" t="1" b="-1"/>
            <a:stretch/>
          </p:blipFill>
          <p:spPr bwMode="auto">
            <a:xfrm>
              <a:off x="6981826" y="3124869"/>
              <a:ext cx="658239" cy="881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6" name="Picture 2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20" t="1" b="-1"/>
            <a:stretch/>
          </p:blipFill>
          <p:spPr bwMode="auto">
            <a:xfrm>
              <a:off x="2681368" y="3124869"/>
              <a:ext cx="658239" cy="881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7" name="Picture 2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20" t="1" b="-1"/>
            <a:stretch/>
          </p:blipFill>
          <p:spPr bwMode="auto">
            <a:xfrm>
              <a:off x="2672111" y="2574551"/>
              <a:ext cx="658239" cy="1003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65" name="TextBox 64"/>
          <p:cNvSpPr txBox="1"/>
          <p:nvPr/>
        </p:nvSpPr>
        <p:spPr>
          <a:xfrm>
            <a:off x="4496437" y="2754225"/>
            <a:ext cx="69923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3200" b="1" dirty="0" smtClean="0"/>
              <a:t>(D)</a:t>
            </a:r>
            <a:endParaRPr lang="en-SG" sz="3200" b="1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1615315" y="5374993"/>
            <a:ext cx="96059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5453809" y="4260963"/>
            <a:ext cx="1258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5485186" y="3741013"/>
            <a:ext cx="1258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5747825" y="3220353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b="1" dirty="0" smtClean="0"/>
              <a:t>M</a:t>
            </a:r>
            <a:endParaRPr lang="en-SG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1079112" y="3237030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b="1" dirty="0" smtClean="0"/>
              <a:t>M</a:t>
            </a:r>
            <a:endParaRPr lang="en-SG" b="1" dirty="0"/>
          </a:p>
        </p:txBody>
      </p:sp>
      <p:sp>
        <p:nvSpPr>
          <p:cNvPr id="71" name="TextBox 70"/>
          <p:cNvSpPr txBox="1"/>
          <p:nvPr/>
        </p:nvSpPr>
        <p:spPr>
          <a:xfrm>
            <a:off x="1177214" y="5091134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b="1" dirty="0" smtClean="0"/>
              <a:t>M</a:t>
            </a:r>
            <a:endParaRPr lang="en-SG" b="1" dirty="0"/>
          </a:p>
        </p:txBody>
      </p:sp>
      <p:cxnSp>
        <p:nvCxnSpPr>
          <p:cNvPr id="72" name="Straight Connector 71"/>
          <p:cNvCxnSpPr/>
          <p:nvPr/>
        </p:nvCxnSpPr>
        <p:spPr>
          <a:xfrm>
            <a:off x="881372" y="4391972"/>
            <a:ext cx="1258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899302" y="3979598"/>
            <a:ext cx="1258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890338" y="4199233"/>
            <a:ext cx="1258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348770" y="385978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smtClean="0"/>
              <a:t>*</a:t>
            </a:r>
            <a:endParaRPr lang="en-SG" dirty="0"/>
          </a:p>
        </p:txBody>
      </p:sp>
      <p:grpSp>
        <p:nvGrpSpPr>
          <p:cNvPr id="66" name="Group 65"/>
          <p:cNvGrpSpPr/>
          <p:nvPr/>
        </p:nvGrpSpPr>
        <p:grpSpPr>
          <a:xfrm>
            <a:off x="3350346" y="4595384"/>
            <a:ext cx="4764889" cy="2047194"/>
            <a:chOff x="-279949" y="1754441"/>
            <a:chExt cx="5169302" cy="2814831"/>
          </a:xfrm>
        </p:grpSpPr>
        <p:grpSp>
          <p:nvGrpSpPr>
            <p:cNvPr id="75" name="Group 74"/>
            <p:cNvGrpSpPr/>
            <p:nvPr/>
          </p:nvGrpSpPr>
          <p:grpSpPr>
            <a:xfrm>
              <a:off x="1567818" y="2155374"/>
              <a:ext cx="3321535" cy="2413898"/>
              <a:chOff x="750179" y="1462574"/>
              <a:chExt cx="7563516" cy="5087487"/>
            </a:xfrm>
          </p:grpSpPr>
          <p:grpSp>
            <p:nvGrpSpPr>
              <p:cNvPr id="81" name="Group 80"/>
              <p:cNvGrpSpPr/>
              <p:nvPr/>
            </p:nvGrpSpPr>
            <p:grpSpPr>
              <a:xfrm>
                <a:off x="750179" y="1462574"/>
                <a:ext cx="7563516" cy="2458920"/>
                <a:chOff x="750179" y="1462574"/>
                <a:chExt cx="7563516" cy="2458920"/>
              </a:xfrm>
            </p:grpSpPr>
            <p:pic>
              <p:nvPicPr>
                <p:cNvPr id="8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0000" r="50000"/>
                <a:stretch/>
              </p:blipFill>
              <p:spPr bwMode="auto">
                <a:xfrm>
                  <a:off x="750179" y="1463491"/>
                  <a:ext cx="2443162" cy="244316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000" t="50000"/>
                <a:stretch/>
              </p:blipFill>
              <p:spPr bwMode="auto">
                <a:xfrm>
                  <a:off x="5892765" y="1478332"/>
                  <a:ext cx="2420930" cy="244316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8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000" b="50000"/>
                <a:stretch/>
              </p:blipFill>
              <p:spPr bwMode="auto">
                <a:xfrm>
                  <a:off x="3329483" y="1462574"/>
                  <a:ext cx="2443164" cy="244316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grpSp>
            <p:nvGrpSpPr>
              <p:cNvPr id="82" name="Group 81"/>
              <p:cNvGrpSpPr/>
              <p:nvPr/>
            </p:nvGrpSpPr>
            <p:grpSpPr>
              <a:xfrm>
                <a:off x="750179" y="4077072"/>
                <a:ext cx="7563516" cy="2472989"/>
                <a:chOff x="750179" y="4077072"/>
                <a:chExt cx="7563516" cy="2472989"/>
              </a:xfrm>
            </p:grpSpPr>
            <p:pic>
              <p:nvPicPr>
                <p:cNvPr id="83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0000" r="50000"/>
                <a:stretch/>
              </p:blipFill>
              <p:spPr bwMode="auto">
                <a:xfrm>
                  <a:off x="750179" y="4106898"/>
                  <a:ext cx="2443162" cy="244316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4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000" b="50000"/>
                <a:stretch/>
              </p:blipFill>
              <p:spPr bwMode="auto">
                <a:xfrm>
                  <a:off x="3329483" y="4106898"/>
                  <a:ext cx="2443164" cy="241333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5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000" t="50000"/>
                <a:stretch/>
              </p:blipFill>
              <p:spPr bwMode="auto">
                <a:xfrm>
                  <a:off x="5895677" y="4077072"/>
                  <a:ext cx="2418018" cy="244316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</p:grpSp>
        <p:sp>
          <p:nvSpPr>
            <p:cNvPr id="76" name="TextBox 75"/>
            <p:cNvSpPr txBox="1"/>
            <p:nvPr/>
          </p:nvSpPr>
          <p:spPr>
            <a:xfrm>
              <a:off x="300943" y="2734018"/>
              <a:ext cx="1290727" cy="5078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>
                  <a:latin typeface="+mj-lt"/>
                </a:rPr>
                <a:t>RFP- </a:t>
              </a:r>
              <a:r>
                <a:rPr lang="en-SG" b="1" dirty="0" err="1" smtClean="0">
                  <a:latin typeface="+mj-lt"/>
                </a:rPr>
                <a:t>BirA</a:t>
              </a:r>
              <a:r>
                <a:rPr lang="en-SG" b="1" dirty="0" smtClean="0">
                  <a:latin typeface="+mj-lt"/>
                </a:rPr>
                <a:t>*</a:t>
              </a:r>
              <a:endParaRPr lang="en-SG" b="1" dirty="0">
                <a:latin typeface="+mj-lt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-279949" y="3648718"/>
              <a:ext cx="1902597" cy="5078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>
                  <a:latin typeface="+mj-lt"/>
                </a:rPr>
                <a:t>RFP- </a:t>
              </a:r>
              <a:r>
                <a:rPr lang="en-SG" b="1" dirty="0" err="1" smtClean="0">
                  <a:latin typeface="+mj-lt"/>
                </a:rPr>
                <a:t>BirA</a:t>
              </a:r>
              <a:r>
                <a:rPr lang="en-SG" b="1" dirty="0" smtClean="0">
                  <a:latin typeface="+mj-lt"/>
                </a:rPr>
                <a:t>*-ATG8</a:t>
              </a:r>
              <a:endParaRPr lang="en-SG" b="1" dirty="0">
                <a:latin typeface="+mj-lt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775644" y="1754442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/>
                <a:t>RFP</a:t>
              </a:r>
              <a:endParaRPr lang="en-SG" b="1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058750" y="1754442"/>
              <a:ext cx="4203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/>
                <a:t>BF</a:t>
              </a:r>
              <a:endParaRPr lang="en-SG" b="1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956253" y="1754441"/>
              <a:ext cx="8030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b="1" dirty="0" smtClean="0"/>
                <a:t>Merge</a:t>
              </a:r>
              <a:endParaRPr lang="en-SG" b="1" dirty="0"/>
            </a:p>
          </p:txBody>
        </p:sp>
      </p:grpSp>
      <p:sp>
        <p:nvSpPr>
          <p:cNvPr id="89" name="TextBox 88"/>
          <p:cNvSpPr txBox="1"/>
          <p:nvPr/>
        </p:nvSpPr>
        <p:spPr>
          <a:xfrm>
            <a:off x="3854915" y="4636576"/>
            <a:ext cx="6415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3200" b="1" dirty="0" smtClean="0"/>
              <a:t>(E)</a:t>
            </a:r>
            <a:endParaRPr lang="en-SG" sz="3200" b="1" dirty="0"/>
          </a:p>
        </p:txBody>
      </p:sp>
    </p:spTree>
    <p:extLst>
      <p:ext uri="{BB962C8B-B14F-4D97-AF65-F5344CB8AC3E}">
        <p14:creationId xmlns:p14="http://schemas.microsoft.com/office/powerpoint/2010/main" val="1020666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2</TotalTime>
  <Words>173</Words>
  <Application>Microsoft Office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cy Macharia</dc:creator>
  <cp:lastModifiedBy>Mercy Macharia</cp:lastModifiedBy>
  <cp:revision>76</cp:revision>
  <dcterms:created xsi:type="dcterms:W3CDTF">2019-04-05T06:37:47Z</dcterms:created>
  <dcterms:modified xsi:type="dcterms:W3CDTF">2019-07-03T10:17:23Z</dcterms:modified>
</cp:coreProperties>
</file>